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A1E9C73-44DA-6876-3A61-B09C5C512D4C}" name="LARA SANOGUERA MIRALLES" initials="LM" userId="S::lara.sanoguera@uva.es::59474501-d47c-4178-90dd-0f7669e4dc9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9126949-E9A6-78C1-C696-DB313B3EB425}" v="2" dt="2024-07-10T10:00:02.890"/>
    <p1510:client id="{D0C2323E-F28A-DCF4-907D-CDC4349A675C}" v="5" dt="2024-07-10T10:52:00.43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552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RA SANOGUERA MIRALLES" userId="S::lara.sanoguera@uva.es::59474501-d47c-4178-90dd-0f7669e4dc9a" providerId="AD" clId="Web-{09126949-E9A6-78C1-C696-DB313B3EB425}"/>
    <pc:docChg chg="mod">
      <pc:chgData name="LARA SANOGUERA MIRALLES" userId="S::lara.sanoguera@uva.es::59474501-d47c-4178-90dd-0f7669e4dc9a" providerId="AD" clId="Web-{09126949-E9A6-78C1-C696-DB313B3EB425}" dt="2024-07-10T10:00:02.890" v="1"/>
      <pc:docMkLst>
        <pc:docMk/>
      </pc:docMkLst>
      <pc:sldChg chg="addCm">
        <pc:chgData name="LARA SANOGUERA MIRALLES" userId="S::lara.sanoguera@uva.es::59474501-d47c-4178-90dd-0f7669e4dc9a" providerId="AD" clId="Web-{09126949-E9A6-78C1-C696-DB313B3EB425}" dt="2024-07-10T10:00:02.890" v="1"/>
        <pc:sldMkLst>
          <pc:docMk/>
          <pc:sldMk cId="2471961744" sldId="265"/>
        </pc:sldMkLst>
        <pc:extLst>
          <p:ext xmlns:p="http://schemas.openxmlformats.org/presentationml/2006/main" uri="{D6D511B9-2390-475A-947B-AFAB55BFBCF1}">
            <pc226:cmChg xmlns="" xmlns:pc226="http://schemas.microsoft.com/office/powerpoint/2022/06/main/command" chg="add">
              <pc226:chgData name="LARA SANOGUERA MIRALLES" userId="S::lara.sanoguera@uva.es::59474501-d47c-4178-90dd-0f7669e4dc9a" providerId="AD" clId="Web-{09126949-E9A6-78C1-C696-DB313B3EB425}" dt="2024-07-10T10:00:02.890" v="1"/>
              <pc2:cmMkLst xmlns:pc2="http://schemas.microsoft.com/office/powerpoint/2019/9/main/command">
                <pc:docMk/>
                <pc:sldMk cId="2471961744" sldId="265"/>
                <pc2:cmMk id="{89CD379E-7711-4AA6-B1C3-CA4C2069E49B}"/>
              </pc2:cmMkLst>
            </pc226:cmChg>
          </p:ext>
        </pc:extLst>
      </pc:sldChg>
    </pc:docChg>
  </pc:docChgLst>
  <pc:docChgLst>
    <pc:chgData name="ELENA BUENO MARTINEZ" userId="S::elena.bueno@uva.es::17af6d7f-f97d-4d3b-89b0-f7257917b592" providerId="AD" clId="Web-{D0C2323E-F28A-DCF4-907D-CDC4349A675C}"/>
    <pc:docChg chg="delSld">
      <pc:chgData name="ELENA BUENO MARTINEZ" userId="S::elena.bueno@uva.es::17af6d7f-f97d-4d3b-89b0-f7257917b592" providerId="AD" clId="Web-{D0C2323E-F28A-DCF4-907D-CDC4349A675C}" dt="2024-07-10T10:52:00.433" v="4"/>
      <pc:docMkLst>
        <pc:docMk/>
      </pc:docMkLst>
      <pc:sldChg chg="delCm">
        <pc:chgData name="ELENA BUENO MARTINEZ" userId="S::elena.bueno@uva.es::17af6d7f-f97d-4d3b-89b0-f7257917b592" providerId="AD" clId="Web-{D0C2323E-F28A-DCF4-907D-CDC4349A675C}" dt="2024-07-10T10:52:00.433" v="4"/>
        <pc:sldMkLst>
          <pc:docMk/>
          <pc:sldMk cId="2471961744" sldId="265"/>
        </pc:sldMkLst>
        <pc:extLst>
          <p:ext xmlns:p="http://schemas.openxmlformats.org/presentationml/2006/main" uri="{D6D511B9-2390-475A-947B-AFAB55BFBCF1}">
            <pc226:cmChg xmlns="" xmlns:pc226="http://schemas.microsoft.com/office/powerpoint/2022/06/main/command" chg="del">
              <pc226:chgData name="ELENA BUENO MARTINEZ" userId="S::elena.bueno@uva.es::17af6d7f-f97d-4d3b-89b0-f7257917b592" providerId="AD" clId="Web-{D0C2323E-F28A-DCF4-907D-CDC4349A675C}" dt="2024-07-10T10:52:00.433" v="4"/>
              <pc2:cmMkLst xmlns:pc2="http://schemas.microsoft.com/office/powerpoint/2019/9/main/command">
                <pc:docMk/>
                <pc:sldMk cId="2471961744" sldId="265"/>
                <pc2:cmMk id="{89CD379E-7711-4AA6-B1C3-CA4C2069E49B}"/>
              </pc2:cmMkLst>
            </pc226:cmChg>
          </p:ext>
        </pc:extLst>
      </pc:sldChg>
      <pc:sldChg chg="del">
        <pc:chgData name="ELENA BUENO MARTINEZ" userId="S::elena.bueno@uva.es::17af6d7f-f97d-4d3b-89b0-f7257917b592" providerId="AD" clId="Web-{D0C2323E-F28A-DCF4-907D-CDC4349A675C}" dt="2024-07-10T10:51:49.698" v="0"/>
        <pc:sldMkLst>
          <pc:docMk/>
          <pc:sldMk cId="1659755483" sldId="266"/>
        </pc:sldMkLst>
      </pc:sldChg>
      <pc:sldChg chg="del">
        <pc:chgData name="ELENA BUENO MARTINEZ" userId="S::elena.bueno@uva.es::17af6d7f-f97d-4d3b-89b0-f7257917b592" providerId="AD" clId="Web-{D0C2323E-F28A-DCF4-907D-CDC4349A675C}" dt="2024-07-10T10:51:54.511" v="2"/>
        <pc:sldMkLst>
          <pc:docMk/>
          <pc:sldMk cId="1607699676" sldId="267"/>
        </pc:sldMkLst>
      </pc:sldChg>
      <pc:sldChg chg="del">
        <pc:chgData name="ELENA BUENO MARTINEZ" userId="S::elena.bueno@uva.es::17af6d7f-f97d-4d3b-89b0-f7257917b592" providerId="AD" clId="Web-{D0C2323E-F28A-DCF4-907D-CDC4349A675C}" dt="2024-07-10T10:51:55.698" v="3"/>
        <pc:sldMkLst>
          <pc:docMk/>
          <pc:sldMk cId="1679264281" sldId="268"/>
        </pc:sldMkLst>
      </pc:sldChg>
      <pc:sldChg chg="del">
        <pc:chgData name="ELENA BUENO MARTINEZ" userId="S::elena.bueno@uva.es::17af6d7f-f97d-4d3b-89b0-f7257917b592" providerId="AD" clId="Web-{D0C2323E-F28A-DCF4-907D-CDC4349A675C}" dt="2024-07-10T10:51:51.104" v="1"/>
        <pc:sldMkLst>
          <pc:docMk/>
          <pc:sldMk cId="4196583303" sldId="26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6843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854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7240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9734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3451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1234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512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06401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3898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114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3916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B25EC-3591-47B7-A979-3FEFA6BE234C}" type="datetimeFigureOut">
              <a:rPr lang="es-ES" smtClean="0"/>
              <a:t>28/0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8667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659806" y="710518"/>
            <a:ext cx="5696143" cy="7363554"/>
            <a:chOff x="429039" y="356977"/>
            <a:chExt cx="6170821" cy="7977183"/>
          </a:xfrm>
        </p:grpSpPr>
        <p:sp>
          <p:nvSpPr>
            <p:cNvPr id="4" name="Rectangle 3"/>
            <p:cNvSpPr/>
            <p:nvPr/>
          </p:nvSpPr>
          <p:spPr>
            <a:xfrm>
              <a:off x="429039" y="356977"/>
              <a:ext cx="5786232" cy="797718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ES" sz="1050" b="1" u="sng" dirty="0">
                  <a:solidFill>
                    <a:srgbClr val="C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GGATCC</a:t>
              </a:r>
              <a:r>
                <a:rPr lang="es-ES" sz="1050" dirty="0">
                  <a:ea typeface="Calibri" panose="020F0502020204030204" pitchFamily="34" charset="0"/>
                  <a:cs typeface="Times New Roman" panose="02020603050405020304" pitchFamily="18" charset="0"/>
                </a:rPr>
                <a:t>agaccagatattaaattggtcttgtaggagttaggccttgaaagagagatttaattgttttatttgtttttttcagctgatgtagtaatctaagcaaggtggtttaaaagttgctctttgtgatggcatgaacagcttttgaaattattataatttaagtattcaacgagtttctgaaattgcattttgttttcttgaag</a:t>
              </a:r>
              <a:r>
                <a:rPr lang="es-ES" sz="1050" b="1" dirty="0">
                  <a:solidFill>
                    <a:schemeClr val="accent6">
                      <a:lumMod val="75000"/>
                    </a:schemeClr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ATTTTTACAGAAATATATTCAGAAAGAAACAGAATGTCTGAGAATAGCAAAACCAAATGTATCAGCCTCAACACAAGCCTCCAGGCAGAAAAAGATGCAGGAAATCAGTAGTTTGGTCAAATACTTCATCAAATGTGCAAACAGAA</a:t>
              </a:r>
              <a:r>
                <a:rPr lang="es-ES" sz="1050" dirty="0">
                  <a:ea typeface="Calibri" panose="020F0502020204030204" pitchFamily="34" charset="0"/>
                  <a:cs typeface="Times New Roman" panose="02020603050405020304" pitchFamily="18" charset="0"/>
                </a:rPr>
                <a:t>gtaagtgatgttataaattataaataaatggcttaacagattactgtcgcgtgagttttttttttttttcagatcattttaaggacttaactgttgcataagtttgttctaaatagaataagataaaagttgagtgtaagtacatataatgatttttatttttattaaaaggtttttttttagggctagtcaagtgaagcgactatgttccaataaaatgttatttgcaaagaaaaaaaaaatgaattttgcttggggccataatttgccaatttcttctctacaaaagaagtttagttaatagtaatttcccaaatggaattatttaaatagttgccattccaagtgtcttatttttgttcaaatttatgtttttctttatttgtttattttgaaatag</a:t>
              </a:r>
              <a:r>
                <a:rPr lang="es-ES" sz="1050" b="1" dirty="0">
                  <a:solidFill>
                    <a:schemeClr val="accent6">
                      <a:lumMod val="75000"/>
                    </a:schemeClr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GAGCACCTAGGCTAAAATGTCAAGAACTCTTAAATTATATCATGGATACAGTGAAAGATTCATCTAATGGTGCTATTTACGGAGCTGATTGTAGCAACATACTACTCAAAGACATTCTTTCTGTGAGAAAATACTGGTGTGAAATATCTCAGCAACAGTGGTTAG</a:t>
              </a:r>
              <a:r>
                <a:rPr lang="es-ES" sz="1050" dirty="0">
                  <a:ea typeface="Calibri" panose="020F0502020204030204" pitchFamily="34" charset="0"/>
                  <a:cs typeface="Times New Roman" panose="02020603050405020304" pitchFamily="18" charset="0"/>
                </a:rPr>
                <a:t>gtatgttttgaaggttgttgtttgtgaatttttcctcatgaaatgaaacttcaccaaagaaagcactctgtctgtatctgtctatatcccccaagtgacctgacagtttaacagtactttagtaaaattatatggttatcgaactgacccttaatttttatttattatgtagcttttgaataaagtcatgaataatatatagttattcctgtcttaaaggcattttatataagataaaattaaatactgatggagtacttttactatgttaaaaataaattagtgcagttttaaaatcctttttctgtatgggattatggaatatttaagttaaattgtaacatttaatacattttgatttttaaaaaatcatgactaataatttttttttttttttaag</a:t>
              </a:r>
              <a:r>
                <a:rPr lang="es-ES" sz="1050" b="1" dirty="0">
                  <a:solidFill>
                    <a:schemeClr val="accent6">
                      <a:lumMod val="75000"/>
                    </a:schemeClr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AATTGTTCTCTGTGTACTTCAGGCTCTATCTGAAACCTTCACAAGATGTTCATAGAGTTTTAGTGGCTAGAATAATTCATGCTGTTACCAAAGGATGCTGTTCTCAGACTGACGGATTAAATTCCAAATTTTTGGACTTTTTTTCCAAGGCTATTCAGTGTGCGAG</a:t>
              </a:r>
              <a:r>
                <a:rPr lang="es-ES" sz="1050" dirty="0">
                  <a:ea typeface="Calibri" panose="020F0502020204030204" pitchFamily="34" charset="0"/>
                  <a:cs typeface="Times New Roman" panose="02020603050405020304" pitchFamily="18" charset="0"/>
                </a:rPr>
                <a:t>gtaatctaatctctttttcttttgttttgtattgaaatacttttgatcttgcaagaccatgttttagactcagtaactaaaaattctaccttaaaataaaacattgatccatcataacagaactagtggattcctaaagagacaaccaagtccaacactttctgaatatccaatatgcagaacactacgtgaagttttcacaccaaataagaactaattttttgtcagtgtgaagtaatgctgtgatttttttttttaatgaatagttttgaaattaagactactgtttgaaaattagggttttgtttttttttctttcagcataccacttcataactgttcagtttgtacagtttgttccccctgttatacccagttgagcttgtttgtttcttcacag</a:t>
              </a:r>
              <a:r>
                <a:rPr lang="es-ES" sz="1050" b="1" dirty="0">
                  <a:solidFill>
                    <a:schemeClr val="accent6">
                      <a:lumMod val="75000"/>
                    </a:schemeClr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ACAAGAAAAGAGCTCTTCAGGTCTAAATCATATCTTAGCAGCTCTTACTATCTTCCTCAAGACTTTGGCTGTCAACTTTCGAATTCGAGTGTGTGAATTAGGAGATGAAATTCTTCCCACTTTGCTTTATATTTGGACTCAACATAGGCTTAATGATTCTTTAAAAGAAGTCATTATTGAATTATTTCAACTGCAAATTTATATCCATCATCCGAAAGGAGCCAAAACCCAAGAAAAAG</a:t>
              </a:r>
              <a:r>
                <a:rPr lang="es-ES" sz="1050" dirty="0">
                  <a:ea typeface="Calibri" panose="020F0502020204030204" pitchFamily="34" charset="0"/>
                  <a:cs typeface="Times New Roman" panose="02020603050405020304" pitchFamily="18" charset="0"/>
                </a:rPr>
                <a:t>gtataaaggaaatgtttactgttttgaatttgcttcttcattcaaacatagaagtctaagtataaaattagtgttctttaggaggatatgactttcctctggatttctctggttgataatgttacttagccatgagaatgtttttcatagagtttttagaatttgaagcagtggtagcagattctgttatgcctttctatagttatctaaatgtaaaatggacagttatgaaatagagtttgtcaaggatcttgtcagaagaggcattagtactgaatggaaggttggaccaggtgtcttctaacgctgatgcagcttgacagctgaataattttgtgggagctagcagtgtaaacagagtacatacataaaaattacattttaattttttggattacag</a:t>
              </a:r>
              <a:r>
                <a:rPr lang="es-ES" sz="1050" b="1" dirty="0">
                  <a:solidFill>
                    <a:schemeClr val="accent6">
                      <a:lumMod val="75000"/>
                    </a:schemeClr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GTGCTTATGAATCAACAAAATGGAGAAGTATTTTATACAACTTATATGATCTGCTAGTGAATGAGATAAGTCATATAGGAAGTAGAGGAAAGTATTCTTCAGGATTTCGTAATATTGCCGTCAAAGAAAATTTGATTGAATTGATGGCAGATATCTGTCACCAG</a:t>
              </a:r>
              <a:r>
                <a:rPr lang="es-ES" sz="1050" dirty="0">
                  <a:ea typeface="Calibri" panose="020F0502020204030204" pitchFamily="34" charset="0"/>
                  <a:cs typeface="Times New Roman" panose="02020603050405020304" pitchFamily="18" charset="0"/>
                </a:rPr>
                <a:t>gtacagtaagtaggtcatgtcacatttagaaatttcctgttaattttttttttaaactgggcattttgggcttttaaaacctgtgttctcacaaaaagcctataaaatgactctgtacatgcaactattcctttcaaactatcagaaatatttggaattacccttttaacttaaaagttaatgcttttgcagatatttga</a:t>
              </a:r>
              <a:r>
                <a:rPr lang="es-ES" sz="1050" b="1" u="sng" dirty="0">
                  <a:solidFill>
                    <a:srgbClr val="C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AAGCTT</a:t>
              </a:r>
              <a:r>
                <a:rPr lang="es-ES" sz="1050" dirty="0">
                  <a:ea typeface="Calibri" panose="020F0502020204030204" pitchFamily="34" charset="0"/>
                  <a:cs typeface="Times New Roman" panose="02020603050405020304" pitchFamily="18" charset="0"/>
                </a:rPr>
                <a:t>tcttgctttatgagttccctgtatcttcatttcagaaagaattttttttccccctaatgaaatattagaagacaatagcaatgaaaaaagtgtatttggccaggcgtggtggctcacacctgtaatcccGgcactttgggaggccaaggcgggcagatcacctgaggttgggagttcaagaccagtctgaccaacatggagaaactctgtccctactaaaaatacaaagttagctgggcatggtggtgcaagcctgtaatcccagctactcgggaggctgaggcaggagaatcacttgaacctgggaggtagaggttgtggtgatacgagatcgtgctgttccactccaacctgggcaacaacagcgaaactctggctcaaaaaaaaaaaaaagaaaaaagtggatttatttttattttacag</a:t>
              </a:r>
              <a:r>
                <a:rPr lang="es-ES" sz="1050" b="1" dirty="0">
                  <a:solidFill>
                    <a:schemeClr val="accent6">
                      <a:lumMod val="75000"/>
                    </a:schemeClr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GTTTTTAATGAAGATACCAGATCCTTGGAGATTTCTCAATCTTACACTACTACACAAAGAGAATCTAGTGATTACAGTGTCCCTTGCAAAAGGAAGAAAATAGAACTAGGCTGGGAAGTAATAAAAGATCACCTTCAGAAGTCACAGAATGATTTTGATCTTGTGCCTTG</a:t>
              </a:r>
              <a:r>
                <a:rPr lang="es-ES" sz="1050" dirty="0">
                  <a:ea typeface="Calibri" panose="020F0502020204030204" pitchFamily="34" charset="0"/>
                  <a:cs typeface="Times New Roman" panose="02020603050405020304" pitchFamily="18" charset="0"/>
                </a:rPr>
                <a:t>gtaaagtgttaccattttctcattcagtgtcattttaatctcttgtatgttatttttcagaaaactttcagtggaatcctttcatctcaaccagaactaagtcatttgtctacccccaaacctattactagcaaagggatatgtgattgccatgacaaatgagatcaatcattaatggctcatttgcttgggccaagtgcagggccacctattttaatcatattgtcatagcaagttaagaaggag</a:t>
              </a:r>
              <a:r>
                <a:rPr lang="es-ES" sz="1050" b="1" u="sng" dirty="0">
                  <a:solidFill>
                    <a:srgbClr val="C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GTCGAC</a:t>
              </a:r>
              <a:endParaRPr lang="en-GB" sz="1050" b="1" u="sng" dirty="0">
                <a:solidFill>
                  <a:srgbClr val="C00000"/>
                </a:solidFill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116211" y="760095"/>
              <a:ext cx="413656" cy="275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dirty="0"/>
                <a:t>Ex4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116211" y="1916548"/>
              <a:ext cx="413656" cy="275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dirty="0"/>
                <a:t>Ex5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116211" y="2997450"/>
              <a:ext cx="413656" cy="275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dirty="0"/>
                <a:t>Ex6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116211" y="4344195"/>
              <a:ext cx="413656" cy="275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dirty="0"/>
                <a:t>Ex7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116211" y="5554256"/>
              <a:ext cx="483649" cy="275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/>
                <a:t>Ex8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116211" y="7210475"/>
              <a:ext cx="413656" cy="275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dirty="0"/>
                <a:t>Ex9</a:t>
              </a: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304801" y="8148222"/>
            <a:ext cx="6248400" cy="1328023"/>
          </a:xfrm>
          <a:prstGeom prst="round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Supplementary </a:t>
            </a:r>
            <a:r>
              <a:rPr lang="en-GB" sz="1200" b="1"/>
              <a:t>Figure S1. </a:t>
            </a:r>
            <a:r>
              <a:rPr lang="en-GB" sz="1200" b="1" dirty="0"/>
              <a:t>Insert sequence of minigene mgATM_4-9.  </a:t>
            </a:r>
            <a:r>
              <a:rPr lang="en-GB" sz="1200" dirty="0"/>
              <a:t>Exons 4 to 9 are indicated in upper case. Structure of the insert (3,731 bp): </a:t>
            </a:r>
            <a:r>
              <a:rPr lang="en-GB" sz="1200" i="1" dirty="0" err="1"/>
              <a:t>Bam</a:t>
            </a:r>
            <a:r>
              <a:rPr lang="en-GB" sz="1200" dirty="0" err="1"/>
              <a:t>HI</a:t>
            </a:r>
            <a:r>
              <a:rPr lang="en-GB" sz="1200" dirty="0"/>
              <a:t> - ivs3 (200 bp) – ex4 (146 bp) – ivs4.1 (200 bp) // ivs4.2 (200 bp) – ex5 (165 bp) – ivs5.1 (200 bp) // ivs5.2 (200 bp) – ex6 (166 bp) – ivs6.1 (200 bp) // ivs6.2 (200 bp) – ex7 (237 bp) – ivs7.1 (200 bp) // ivs7.2 (200 bp) – ex8 (164 bp) – ivs8.1 (200 bp) -</a:t>
            </a:r>
            <a:r>
              <a:rPr lang="en-GB" sz="1200" i="1" dirty="0" err="1"/>
              <a:t>Hin</a:t>
            </a:r>
            <a:r>
              <a:rPr lang="en-GB" sz="1200" dirty="0" err="1"/>
              <a:t>dIII</a:t>
            </a:r>
            <a:r>
              <a:rPr lang="en-GB" sz="1200" dirty="0"/>
              <a:t>- ivs8.2 (423 bp) – ex9 (170 bp) - ivs9 (246 bp) - </a:t>
            </a:r>
            <a:r>
              <a:rPr lang="en-GB" sz="1200" i="1" dirty="0" err="1"/>
              <a:t>Sal</a:t>
            </a:r>
            <a:r>
              <a:rPr lang="en-GB" sz="1200" dirty="0" err="1"/>
              <a:t>I</a:t>
            </a:r>
            <a:r>
              <a:rPr lang="en-GB" sz="1200" dirty="0"/>
              <a:t> (shortened introns are indicated by a double slash //)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1863A937-7562-FB4F-8D2F-9714C6E290BB}"/>
              </a:ext>
            </a:extLst>
          </p:cNvPr>
          <p:cNvSpPr txBox="1"/>
          <p:nvPr/>
        </p:nvSpPr>
        <p:spPr>
          <a:xfrm>
            <a:off x="578842" y="497868"/>
            <a:ext cx="847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solidFill>
                  <a:srgbClr val="C00000"/>
                </a:solidFill>
              </a:rPr>
              <a:t>RE: </a:t>
            </a:r>
            <a:r>
              <a:rPr lang="es-ES" sz="1200" b="1" i="1" dirty="0" err="1">
                <a:solidFill>
                  <a:srgbClr val="C00000"/>
                </a:solidFill>
              </a:rPr>
              <a:t>Bam</a:t>
            </a:r>
            <a:r>
              <a:rPr lang="es-ES" sz="1200" b="1" dirty="0" err="1">
                <a:solidFill>
                  <a:srgbClr val="C00000"/>
                </a:solidFill>
              </a:rPr>
              <a:t>HI</a:t>
            </a:r>
            <a:endParaRPr lang="es-ES" sz="1200" b="1" dirty="0">
              <a:solidFill>
                <a:srgbClr val="C00000"/>
              </a:solidFill>
            </a:endParaRP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8349D7BC-04DD-A33E-7576-174F80E34039}"/>
              </a:ext>
            </a:extLst>
          </p:cNvPr>
          <p:cNvSpPr txBox="1"/>
          <p:nvPr/>
        </p:nvSpPr>
        <p:spPr>
          <a:xfrm>
            <a:off x="3635800" y="7871223"/>
            <a:ext cx="847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solidFill>
                  <a:srgbClr val="C00000"/>
                </a:solidFill>
              </a:rPr>
              <a:t>RE: </a:t>
            </a:r>
            <a:r>
              <a:rPr lang="es-ES" sz="1200" b="1" i="1" dirty="0" err="1">
                <a:solidFill>
                  <a:srgbClr val="C00000"/>
                </a:solidFill>
              </a:rPr>
              <a:t>Sal</a:t>
            </a:r>
            <a:r>
              <a:rPr lang="es-ES" sz="1200" b="1" dirty="0" err="1">
                <a:solidFill>
                  <a:srgbClr val="C00000"/>
                </a:solidFill>
              </a:rPr>
              <a:t>I</a:t>
            </a:r>
            <a:endParaRPr lang="es-ES" sz="1200" b="1" i="1" dirty="0">
              <a:solidFill>
                <a:srgbClr val="C00000"/>
              </a:solidFill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D103EB1C-5310-4C61-9464-FC7F0B4ACC5E}"/>
              </a:ext>
            </a:extLst>
          </p:cNvPr>
          <p:cNvSpPr txBox="1"/>
          <p:nvPr/>
        </p:nvSpPr>
        <p:spPr>
          <a:xfrm>
            <a:off x="5844546" y="6139705"/>
            <a:ext cx="847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solidFill>
                  <a:srgbClr val="C00000"/>
                </a:solidFill>
              </a:rPr>
              <a:t>RE: </a:t>
            </a:r>
            <a:r>
              <a:rPr lang="es-ES" sz="1200" b="1" i="1" dirty="0" err="1">
                <a:solidFill>
                  <a:srgbClr val="C00000"/>
                </a:solidFill>
              </a:rPr>
              <a:t>Hind</a:t>
            </a:r>
            <a:r>
              <a:rPr lang="es-ES" sz="1200" b="1" dirty="0" err="1">
                <a:solidFill>
                  <a:srgbClr val="C00000"/>
                </a:solidFill>
              </a:rPr>
              <a:t>III</a:t>
            </a:r>
            <a:endParaRPr lang="es-ES" sz="1200" b="1" i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1961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03</TotalTime>
  <Words>168</Words>
  <Application>Microsoft Office PowerPoint</Application>
  <PresentationFormat>A4 (210 x 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 Bueno Martinez</dc:creator>
  <cp:lastModifiedBy>INES LLINARES BURGUET</cp:lastModifiedBy>
  <cp:revision>175</cp:revision>
  <dcterms:created xsi:type="dcterms:W3CDTF">2020-03-02T12:12:44Z</dcterms:created>
  <dcterms:modified xsi:type="dcterms:W3CDTF">2025-01-28T10:06:40Z</dcterms:modified>
</cp:coreProperties>
</file>